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7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4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4574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9924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1013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7016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5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3407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407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96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4490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1754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180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7C9FC-B213-47EB-8F74-3FA99D891ED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1C8B49-9C2C-4D46-96BD-EACB7D0987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58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58E010E-DA14-A5D7-9E2D-DED0EB5703FD}"/>
              </a:ext>
            </a:extLst>
          </p:cNvPr>
          <p:cNvSpPr txBox="1"/>
          <p:nvPr/>
        </p:nvSpPr>
        <p:spPr>
          <a:xfrm>
            <a:off x="0" y="1997839"/>
            <a:ext cx="99060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/>
              <a:t>Supplementary Data 5. Representative predicted structures of candidate small RNAs in RSC-EXO</a:t>
            </a:r>
            <a:br>
              <a:rPr lang="en-US" altLang="ko-KR" dirty="0"/>
            </a:br>
            <a:r>
              <a:rPr lang="en-US" altLang="ko-KR" dirty="0"/>
              <a:t>Two representative candidate small RNA sequences (LYNE01003137_18835 and LYNE01061673_42069) identified through exploratory computational analysis are shown. These candidates exhibited relatively high read abundance and predicted secondary structures compatible with miRNA-like features; however, their biological function and classification remain unvalidate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52856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31F73954-19D6-0AD2-017F-2C4386CDBA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987" y="0"/>
            <a:ext cx="95880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451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4132AFD4-C9F0-C40F-A8DC-8439CE1B47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935" y="0"/>
            <a:ext cx="955012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8270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</TotalTime>
  <Words>59</Words>
  <Application>Microsoft Office PowerPoint</Application>
  <PresentationFormat>A4 용지(210x297mm)</PresentationFormat>
  <Paragraphs>1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ehyun Ha</dc:creator>
  <cp:lastModifiedBy>Daehyun Ha</cp:lastModifiedBy>
  <cp:revision>3</cp:revision>
  <dcterms:created xsi:type="dcterms:W3CDTF">2026-04-02T07:02:24Z</dcterms:created>
  <dcterms:modified xsi:type="dcterms:W3CDTF">2026-05-07T05:55:52Z</dcterms:modified>
</cp:coreProperties>
</file>